
<file path=[Content_Types].xml><?xml version="1.0" encoding="utf-8"?>
<Types xmlns="http://schemas.openxmlformats.org/package/2006/content-types">
  <Default Extension="jpeg" ContentType="image/jpeg"/>
  <Default Extension="jp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en-BM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00" autoAdjust="0"/>
    <p:restoredTop sz="94660"/>
  </p:normalViewPr>
  <p:slideViewPr>
    <p:cSldViewPr snapToGrid="0">
      <p:cViewPr varScale="1">
        <p:scale>
          <a:sx n="65" d="100"/>
          <a:sy n="65" d="100"/>
        </p:scale>
        <p:origin x="936" y="7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1E45EE-3B1F-54AC-6F5D-490DCE12B33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3C57302E-2749-7697-D528-DB06EFA67D4A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AB9DF82-7438-0056-9FCB-CF3CE390494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1164A6-0C40-3CED-811A-08331A7F6F1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EB5EA5B5-9D21-9D64-ED7A-893AA16629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02191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EDC1B9B-FA38-2B0C-9231-D6AC16B03A3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877F1BE-369F-CFBC-30EB-88F443E8247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A0F7270-F91D-0443-31A4-54D507FFED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C78D78A-7E83-B4A5-8D74-7D9DF3D35B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D8B8FFA-4ABA-6073-91FC-7D38C0F708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41378446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830E73D2-482E-81FB-1183-DFA19A78B79D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F3E12E1E-46D6-E576-2E40-BE408C5078C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281A1C0-8C80-F4CD-2417-031DF60334A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657C84-D671-A984-FFE0-8FF78E54CA0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2483011-3C4E-F532-3F42-3A5AD8B0185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15607435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CB24FF0-6758-9A0C-32E9-D6D988C08CE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EFA5D81-F71D-72D1-FBEF-DB3E87292B7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62A6854-407B-4BDF-09E3-8E36890F3B7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F76CA6-3AA8-6FAB-0EEC-A259E55AB29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2A758C0-5F38-57C1-F02E-AC494D40B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410254365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8DDEBA3-0536-6F77-3728-930C851A99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35A9340-802E-816A-7C7A-1A0711008AF9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82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82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66518F7-8B89-C36E-1355-74A064F2B55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2FF87C-7FD9-1867-068D-D67D3416887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794F8F9-9F8E-F484-8926-C2EC99463C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76372002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D390880-80BE-44D0-790C-5E2B8758FD1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C0529C8C-0C5C-5051-0452-8EFADB02C95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491D9DD0-9749-2136-E259-8457B8D64FB2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2629B96-7BB2-BBEE-4CAC-579507E98C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174AD7A-C7B7-7B5C-038B-C4E2136606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92C47DFD-6214-72FF-3D64-C3456F67435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27112858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7C30714-91B1-670F-5CDB-CD51AF8CE7D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8DEE8E5-0281-4F2A-CE58-2A4844F6C8B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EC6FE76-198E-807F-DF52-12910E4B390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A7A4D81D-73AA-87D9-DD7B-139ACBBB331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A1EA734-D1F4-6D57-6268-AB2F10967A3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F0D506D5-4651-526C-8C40-40D17837FA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92490E30-6D5A-004D-BDE4-BA326C7DA52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77DE8866-1B4E-817E-7ECC-A187D3F52FB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391068287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28FC357-34A6-B548-5C13-4B84E668DA2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F8065051-15E6-6DFA-A693-034197BAF51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F9BBA6EF-D4D7-C355-541C-8F6ADF82FF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513A5900-4520-8C07-69D7-5617707C4D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8393325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9D7C770A-B734-44E1-19AB-F218A01FC9F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B7027700-19D8-4A30-44F0-38BB77312A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75C69C9-FFAC-8010-16DB-6D4B387740F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370446727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15E914-23E7-D39A-080E-6721CC608CF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7E4AE636-06CA-D255-2348-AE40441886F4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A61963-B788-5377-2493-8114264D6E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F3154B61-5032-3DE3-EC39-7688108A6A1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E17414E7-A5DD-E680-4AED-38FBB5901D4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2B79347-D4A4-789F-39A1-05FD50A68A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268273383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52C83E2-8249-C8F4-779E-ECDC3EC2D5C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975EABE-29ED-543C-9680-83C6D62126D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BM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F86D0C40-B21E-3AF4-6E05-AD228E0A16E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6835FA3-71E1-E74D-D1D0-BCEAE85B356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8F0BC72-5EAD-34E4-F9F0-4942EAB833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BM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4D5DA3-0898-751A-758A-266E547BF51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113577566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35D98187-DB03-9EEE-B376-A7FF9F82C43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BM"/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541847B-F354-49CB-1009-EAD5F59E14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BM"/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9CBA0CB-CBD9-42A2-9F9F-A5DB7C257508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120DF2-96DE-4828-8619-CE513FE5CF91}" type="datetimeFigureOut">
              <a:rPr lang="en-BM" smtClean="0"/>
              <a:t>18/03/2025</a:t>
            </a:fld>
            <a:endParaRPr lang="en-BM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2FCE875-4D9D-9B3E-A5C8-F2280C5F1842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en-BM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EB09239-7EC6-8FFE-3DBF-653F05CC1106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39A73D7-4A2D-4FAA-8ADF-F8434DB1A180}" type="slidenum">
              <a:rPr lang="en-BM" smtClean="0"/>
              <a:t>‹#›</a:t>
            </a:fld>
            <a:endParaRPr lang="en-BM"/>
          </a:p>
        </p:txBody>
      </p:sp>
    </p:spTree>
    <p:extLst>
      <p:ext uri="{BB962C8B-B14F-4D97-AF65-F5344CB8AC3E}">
        <p14:creationId xmlns:p14="http://schemas.microsoft.com/office/powerpoint/2010/main" val="3278233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BM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EF4D030B-8923-E760-AC65-100A3F98F372}"/>
              </a:ext>
            </a:extLst>
          </p:cNvPr>
          <p:cNvSpPr txBox="1"/>
          <p:nvPr/>
        </p:nvSpPr>
        <p:spPr>
          <a:xfrm>
            <a:off x="6741400" y="3458744"/>
            <a:ext cx="5450600" cy="1754326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BM" b="1" dirty="0"/>
              <a:t>Supplementary Figure S4</a:t>
            </a:r>
            <a:r>
              <a:rPr lang="en-US" dirty="0"/>
              <a:t>. </a:t>
            </a:r>
            <a:r>
              <a:rPr lang="en-BM" dirty="0"/>
              <a:t>Venn diagram displaying the shared </a:t>
            </a:r>
            <a:r>
              <a:rPr lang="en-BM" dirty="0" err="1"/>
              <a:t>OTUs</a:t>
            </a:r>
            <a:r>
              <a:rPr lang="en-BM" dirty="0"/>
              <a:t> between freshwater and terrestrial habitats from</a:t>
            </a:r>
            <a:r>
              <a:rPr lang="en-US" dirty="0"/>
              <a:t> </a:t>
            </a:r>
            <a:r>
              <a:rPr lang="en-BM" dirty="0"/>
              <a:t>both lakes. Numbers refer to the total shared </a:t>
            </a:r>
            <a:r>
              <a:rPr lang="en-BM" dirty="0" err="1"/>
              <a:t>OTUs</a:t>
            </a:r>
            <a:r>
              <a:rPr lang="en-BM" dirty="0"/>
              <a:t>, and are differentiated between</a:t>
            </a:r>
            <a:r>
              <a:rPr lang="en-US" dirty="0"/>
              <a:t> </a:t>
            </a:r>
            <a:r>
              <a:rPr lang="en-BM" i="1" dirty="0" err="1"/>
              <a:t>Peronosporomycetes</a:t>
            </a:r>
            <a:r>
              <a:rPr lang="en-BM" dirty="0"/>
              <a:t> (violet) and </a:t>
            </a:r>
            <a:r>
              <a:rPr lang="en-BM" i="1" dirty="0" err="1"/>
              <a:t>Saprolegniomycetes</a:t>
            </a:r>
            <a:r>
              <a:rPr lang="en-BM" dirty="0"/>
              <a:t> (green) in</a:t>
            </a:r>
            <a:r>
              <a:rPr lang="en-US" dirty="0"/>
              <a:t> </a:t>
            </a:r>
            <a:r>
              <a:rPr lang="en-BM" dirty="0"/>
              <a:t>parentheses.</a:t>
            </a:r>
          </a:p>
        </p:txBody>
      </p:sp>
      <p:pic>
        <p:nvPicPr>
          <p:cNvPr id="9" name="Picture 8" descr="A diagram of a number of different types of water&#10;&#10;AI-generated content may be incorrect.">
            <a:extLst>
              <a:ext uri="{FF2B5EF4-FFF2-40B4-BE49-F238E27FC236}">
                <a16:creationId xmlns:a16="http://schemas.microsoft.com/office/drawing/2014/main" id="{05C51D98-38E5-2CA1-0325-5FD180CE19EB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1460090"/>
            <a:ext cx="6741401" cy="5320748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D6C1F6B3-E86D-B852-D3A3-62EB26A28705}"/>
              </a:ext>
            </a:extLst>
          </p:cNvPr>
          <p:cNvSpPr txBox="1"/>
          <p:nvPr/>
        </p:nvSpPr>
        <p:spPr>
          <a:xfrm>
            <a:off x="-1" y="77162"/>
            <a:ext cx="12300155" cy="94795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A Glimpse into </a:t>
            </a:r>
            <a:r>
              <a:rPr lang="en-US" sz="1600" b="1" i="1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Oomycota</a:t>
            </a:r>
            <a:r>
              <a:rPr lang="en-US" sz="1600" b="1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Diversity in Freshwater Lakes and Adjacent Forests Using a Metabarcoding Approach</a:t>
            </a:r>
          </a:p>
          <a:p>
            <a:pPr marL="0" marR="0">
              <a:lnSpc>
                <a:spcPct val="107000"/>
              </a:lnSpc>
              <a:spcBef>
                <a:spcPts val="0"/>
              </a:spcBef>
              <a:spcAft>
                <a:spcPts val="600"/>
              </a:spcAft>
            </a:pP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ossein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asigol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arcel Dominik Solbach, Mohammad Javad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Pourmoghaddam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Reza Ahadi, Reza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Mostowfizadeh-Ghalamfarsa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Seyedeh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 Roksana Taheri, Sven Patrik Tobias-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Hünefeldt</a:t>
            </a:r>
            <a:r>
              <a:rPr lang="en-US" sz="1600" dirty="0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, Michael Bonkowski, Hans-Peter </a:t>
            </a:r>
            <a:r>
              <a:rPr lang="en-US" sz="1600" dirty="0" err="1">
                <a:effectLst/>
                <a:latin typeface="Calibri" panose="020F0502020204030204" pitchFamily="34" charset="0"/>
                <a:ea typeface="Calibri" panose="020F0502020204030204" pitchFamily="34" charset="0"/>
              </a:rPr>
              <a:t>Grossart</a:t>
            </a:r>
            <a:endParaRPr lang="en-US" sz="1600" dirty="0">
              <a:effectLst/>
              <a:latin typeface="Calibri" panose="020F0502020204030204" pitchFamily="34" charset="0"/>
              <a:ea typeface="Calibri" panose="020F0502020204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5121512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3</TotalTime>
  <Words>88</Words>
  <Application>Microsoft Office PowerPoint</Application>
  <PresentationFormat>Widescreen</PresentationFormat>
  <Paragraphs>3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Calibri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Amy Maas</dc:creator>
  <cp:lastModifiedBy>Amy Maas</cp:lastModifiedBy>
  <cp:revision>3</cp:revision>
  <dcterms:created xsi:type="dcterms:W3CDTF">2025-03-18T19:50:26Z</dcterms:created>
  <dcterms:modified xsi:type="dcterms:W3CDTF">2025-03-18T20:20:22Z</dcterms:modified>
</cp:coreProperties>
</file>